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2" d="100"/>
          <a:sy n="122" d="100"/>
        </p:scale>
        <p:origin x="114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7867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3979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63203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8420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7082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753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2724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9975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54161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8777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3599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00083-E8B1-4357-BAFE-F75494982A5F}" type="datetimeFigureOut">
              <a:rPr lang="de-DE" smtClean="0"/>
              <a:t>16.0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6BF492-9439-4929-97E6-521A0B93378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5172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702068" y="0"/>
            <a:ext cx="9059348" cy="6176107"/>
            <a:chOff x="702068" y="0"/>
            <a:chExt cx="9059348" cy="6176107"/>
          </a:xfrm>
        </p:grpSpPr>
        <p:sp>
          <p:nvSpPr>
            <p:cNvPr id="3" name="Textfeld 2"/>
            <p:cNvSpPr txBox="1"/>
            <p:nvPr/>
          </p:nvSpPr>
          <p:spPr>
            <a:xfrm>
              <a:off x="906586" y="5714442"/>
              <a:ext cx="8854830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5 Appendix.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ean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rrelation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etween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xpecte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nfluence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sample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mpare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he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5000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bootstrappe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amples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or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ach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xclusion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nterval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068" y="0"/>
              <a:ext cx="8989010" cy="57144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34162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Philipps-Universität Mar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ukas Kirchner</dc:creator>
  <cp:lastModifiedBy>Lukas Kirchner</cp:lastModifiedBy>
  <cp:revision>9</cp:revision>
  <dcterms:created xsi:type="dcterms:W3CDTF">2023-03-21T12:14:56Z</dcterms:created>
  <dcterms:modified xsi:type="dcterms:W3CDTF">2024-02-16T16:51:03Z</dcterms:modified>
</cp:coreProperties>
</file>